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60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4" autoAdjust="0"/>
    <p:restoredTop sz="94660"/>
  </p:normalViewPr>
  <p:slideViewPr>
    <p:cSldViewPr snapToGrid="0">
      <p:cViewPr varScale="1">
        <p:scale>
          <a:sx n="83" d="100"/>
          <a:sy n="83" d="100"/>
        </p:scale>
        <p:origin x="85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0000DE-E825-7BA1-FB3A-1BFC7B6FAB8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3B897CE-6644-E154-CFFD-C07B6B1E385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25AB0E-A697-A322-8BF7-B6EEDF0F4E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B8234-909B-4191-969A-7CA72BDB605F}" type="datetimeFigureOut">
              <a:rPr lang="en-ZA" smtClean="0"/>
              <a:t>2025/05/22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D3D206-EBB0-6F65-D7A7-C952AB4919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E94414-07B2-0543-6220-6BE2C78E57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FD85F-8C3C-4AF5-A863-F9581B02414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6456952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052C91-9A2C-6665-9CE4-769880A23B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EA9A379-DEB9-06A2-89B0-0F8AEFA7F85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B76263-355E-F212-9349-E3B76822DF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B8234-909B-4191-969A-7CA72BDB605F}" type="datetimeFigureOut">
              <a:rPr lang="en-ZA" smtClean="0"/>
              <a:t>2025/05/22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D22553-8C96-1A2A-5D37-EBA9B616B5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195339-7715-994E-95A8-478308FDF8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FD85F-8C3C-4AF5-A863-F9581B02414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8069061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66CC34E-1C02-EEFC-34F1-FC6849628D8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0441823-A535-E563-0C21-4602498B4F9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2C28E1-695F-F02D-7132-9EC4A5F3E3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B8234-909B-4191-969A-7CA72BDB605F}" type="datetimeFigureOut">
              <a:rPr lang="en-ZA" smtClean="0"/>
              <a:t>2025/05/22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9045EA-476D-FF39-7090-40943023A3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C92C6E-F020-095F-6617-256B2DE52E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FD85F-8C3C-4AF5-A863-F9581B02414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5062412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908D8A-CE69-F5B2-7E90-276B878B89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138B32D-B150-1105-224D-C6FDFC4C650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9C20B6-6C6A-9FD9-0925-7A92CDDB7D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B8234-909B-4191-969A-7CA72BDB605F}" type="datetimeFigureOut">
              <a:rPr lang="en-ZA" smtClean="0"/>
              <a:t>2025/05/22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D80E2F-5BF4-F0E2-EDA0-02403863CB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20E61B-03B0-4456-609D-2FAC608881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FD85F-8C3C-4AF5-A863-F9581B02414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017492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3A2277-59BD-2091-67E0-3D2ACA2FE3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57DDEDD-6EEE-25D2-12A7-8E22DC63CB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3BDC13-A661-EDB0-C136-521B041778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B8234-909B-4191-969A-7CA72BDB605F}" type="datetimeFigureOut">
              <a:rPr lang="en-ZA" smtClean="0"/>
              <a:t>2025/05/22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A96F1A-CBFD-BC1F-A754-0F0139D597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0CA099-216D-3A70-758B-FB84224969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FD85F-8C3C-4AF5-A863-F9581B02414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2645461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15BA55-8F2D-F571-8CBF-C6779FF1F4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65EACAD-63DE-CDFE-A8DC-74EE511153E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CB5DF48-3553-74CC-B505-62B9A1FA7D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C60C2DB-0A63-3E2D-2B9F-5AA3FC154C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B8234-909B-4191-969A-7CA72BDB605F}" type="datetimeFigureOut">
              <a:rPr lang="en-ZA" smtClean="0"/>
              <a:t>2025/05/22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D29F492-1859-8A4E-88BB-6D7B41799F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C15EBAD-4ABA-2874-F7B0-C0D2D814B4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FD85F-8C3C-4AF5-A863-F9581B02414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0274166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37A278-2333-5B61-D6AC-B27A4C81EC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ABEECB1-314A-93A5-AE8D-671A446A94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64C9D28-09F0-20F1-0515-D62EDEC4BC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597DA62-8EEE-1369-CC48-CFEFA9541F4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42177DA-952C-1544-AF78-A37BCD4E1BF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233A5BB-8762-9F27-5EFC-D5C04228B4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B8234-909B-4191-969A-7CA72BDB605F}" type="datetimeFigureOut">
              <a:rPr lang="en-ZA" smtClean="0"/>
              <a:t>2025/05/22</a:t>
            </a:fld>
            <a:endParaRPr lang="en-Z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8CCF3E7-B1EA-CF36-9A5A-D846F83F35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65B5749-06F4-E47D-98C5-D358D19A13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FD85F-8C3C-4AF5-A863-F9581B02414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8663261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4DA52A-2845-FC77-06A8-37F5DCD165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E0E1EA3-27FB-7F04-3804-8A6BE30836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B8234-909B-4191-969A-7CA72BDB605F}" type="datetimeFigureOut">
              <a:rPr lang="en-ZA" smtClean="0"/>
              <a:t>2025/05/22</a:t>
            </a:fld>
            <a:endParaRPr lang="en-Z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BB52F7B-651B-3A05-C697-6F77EB206D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67B2764-7A85-E24D-9D2C-5276C3FB61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FD85F-8C3C-4AF5-A863-F9581B02414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7041633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F4602B8-33CD-9A6C-2826-153D2FDB6C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B8234-909B-4191-969A-7CA72BDB605F}" type="datetimeFigureOut">
              <a:rPr lang="en-ZA" smtClean="0"/>
              <a:t>2025/05/22</a:t>
            </a:fld>
            <a:endParaRPr lang="en-Z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588765D-9046-230F-B2DA-1540A8A895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7D187DB-6458-E65A-DA5A-ED17740E77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FD85F-8C3C-4AF5-A863-F9581B02414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0549638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BBE8B3-77DB-9032-F7CC-EC7A897ADD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6B25DAA-F237-2B35-96C3-B3233A06BCC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CAFD552-68D7-7481-EE5B-C4DE90A3384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720796A-090C-29F1-9207-A15657FD43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B8234-909B-4191-969A-7CA72BDB605F}" type="datetimeFigureOut">
              <a:rPr lang="en-ZA" smtClean="0"/>
              <a:t>2025/05/22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AC0EAEE-FF74-AF99-3DE6-6F172F051D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80D2007-9B3C-E7A6-1874-F67E78798B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FD85F-8C3C-4AF5-A863-F9581B02414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6208113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64B8A8-3C80-66FE-7DBC-763AB88AA9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41A9675-0A8A-02EF-B672-512EAD5D769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2910B66-EE73-1A34-048E-655E476F51F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1698C08-AD75-4C82-2698-E29FFBF516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B8234-909B-4191-969A-7CA72BDB605F}" type="datetimeFigureOut">
              <a:rPr lang="en-ZA" smtClean="0"/>
              <a:t>2025/05/22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6BC14B4-2866-3E6C-3CE7-00EF3F0F38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45FA379-0AE2-2E03-3CC8-83EF8F664D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FD85F-8C3C-4AF5-A863-F9581B02414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5055560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4E82098-318D-CD81-C811-444DA6DCAC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62EE21-826A-773D-1981-19AC800459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0A9019-F8BF-8A69-047A-C0F377D7008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01B8234-909B-4191-969A-7CA72BDB605F}" type="datetimeFigureOut">
              <a:rPr lang="en-ZA" smtClean="0"/>
              <a:t>2025/05/22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640010-478B-1A42-9FEB-FB34E29BDA6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5B39CC-D224-448D-CF5B-30965417491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C0FD85F-8C3C-4AF5-A863-F9581B02414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1516917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616231A0-152B-4547-D233-482584122A17}"/>
              </a:ext>
            </a:extLst>
          </p:cNvPr>
          <p:cNvSpPr txBox="1"/>
          <p:nvPr/>
        </p:nvSpPr>
        <p:spPr>
          <a:xfrm>
            <a:off x="1848907" y="5483819"/>
            <a:ext cx="1012363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Figure 1: </a:t>
            </a:r>
            <a:r>
              <a:rPr lang="en-GB" sz="12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Determination of cytotoxicity of individual anti-HIV-1 drugs in TZM-bl cells using the </a:t>
            </a:r>
            <a:r>
              <a:rPr lang="en-GB" sz="1200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ellTiter</a:t>
            </a:r>
            <a:r>
              <a:rPr lang="en-GB" sz="12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Glo</a:t>
            </a:r>
            <a:r>
              <a:rPr lang="en-GB" sz="1200" kern="1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®</a:t>
            </a:r>
            <a:r>
              <a:rPr lang="en-GB" sz="12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assay.</a:t>
            </a:r>
            <a:endParaRPr lang="en-ZA" sz="1200" kern="100" dirty="0">
              <a:effectLst/>
              <a:latin typeface="Times New Roman" panose="0202060305040502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algn="just"/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Z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 descr="A black background with a black square&#10;&#10;AI-generated content may be incorrect.">
            <a:extLst>
              <a:ext uri="{FF2B5EF4-FFF2-40B4-BE49-F238E27FC236}">
                <a16:creationId xmlns:a16="http://schemas.microsoft.com/office/drawing/2014/main" id="{8AA906B6-A7FE-49D3-9698-8D331A916F2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74148" y="131047"/>
            <a:ext cx="8081586" cy="53527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552261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71179EEB-A48B-8073-0500-E84B9790B55B}"/>
              </a:ext>
            </a:extLst>
          </p:cNvPr>
          <p:cNvSpPr txBox="1"/>
          <p:nvPr/>
        </p:nvSpPr>
        <p:spPr>
          <a:xfrm>
            <a:off x="1375843" y="5127717"/>
            <a:ext cx="103772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GB" sz="12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Figure 2: </a:t>
            </a:r>
            <a:r>
              <a:rPr lang="en-GB" sz="12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Determination of cytotoxicity of crude extracts and anti-HIV-1 drug combination in TZM-bl cells using the CellTitre Glo</a:t>
            </a:r>
            <a:r>
              <a:rPr lang="en-GB" sz="1200" kern="1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®</a:t>
            </a:r>
            <a:r>
              <a:rPr lang="en-GB" sz="12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assay. </a:t>
            </a:r>
            <a:endParaRPr lang="en-ZA" sz="12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Picture 2" descr="A group of colorful rectangular objects&#10;&#10;AI-generated content may be incorrect.">
            <a:extLst>
              <a:ext uri="{FF2B5EF4-FFF2-40B4-BE49-F238E27FC236}">
                <a16:creationId xmlns:a16="http://schemas.microsoft.com/office/drawing/2014/main" id="{1947A78E-F3ED-46FB-1451-9CB10768C1F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38725" y="512065"/>
            <a:ext cx="8295066" cy="44937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509276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D52EA3D-BA7C-3710-B1F7-859469113DCF}"/>
              </a:ext>
            </a:extLst>
          </p:cNvPr>
          <p:cNvSpPr txBox="1"/>
          <p:nvPr/>
        </p:nvSpPr>
        <p:spPr>
          <a:xfrm>
            <a:off x="2044842" y="5474208"/>
            <a:ext cx="85336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2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ZA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ZA" sz="12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ZA" sz="120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HIV-1 p24 ELISA Standard Curve.</a:t>
            </a:r>
            <a:r>
              <a:rPr lang="en-Z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pic>
        <p:nvPicPr>
          <p:cNvPr id="6" name="Picture 5" descr="A graph with a line and numbers&#10;&#10;AI-generated content may be incorrect.">
            <a:extLst>
              <a:ext uri="{FF2B5EF4-FFF2-40B4-BE49-F238E27FC236}">
                <a16:creationId xmlns:a16="http://schemas.microsoft.com/office/drawing/2014/main" id="{2A646388-E223-6B86-772A-B1B1220A5D9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4842" y="517489"/>
            <a:ext cx="7672182" cy="48060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2274528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AEC3AFDF-88A0-DACA-6F30-F6A16D001EBC}"/>
              </a:ext>
            </a:extLst>
          </p:cNvPr>
          <p:cNvSpPr txBox="1"/>
          <p:nvPr/>
        </p:nvSpPr>
        <p:spPr>
          <a:xfrm>
            <a:off x="1647506" y="486137"/>
            <a:ext cx="7704838" cy="13029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buNone/>
            </a:pP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1: </a:t>
            </a:r>
            <a:r>
              <a:rPr lang="en-ZA" sz="12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ractional inhibitory concentration index (FICI) calculations for PN and </a:t>
            </a:r>
            <a:r>
              <a:rPr lang="en-ZA" sz="12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G. sericocephala</a:t>
            </a:r>
            <a:r>
              <a:rPr lang="en-ZA" sz="12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</a:p>
          <a:p>
            <a:pPr algn="just">
              <a:buNone/>
            </a:pPr>
            <a:r>
              <a:rPr lang="en-ZA" sz="12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versus the ART drugs.</a:t>
            </a:r>
          </a:p>
          <a:p>
            <a:pPr algn="just">
              <a:spcAft>
                <a:spcPts val="800"/>
              </a:spcAft>
            </a:pPr>
            <a:r>
              <a:rPr lang="en-ZA" sz="12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 </a:t>
            </a:r>
          </a:p>
          <a:p>
            <a:endParaRPr lang="en-ZA" sz="3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778D42DC-D461-4193-537E-8655FD2148F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07358526"/>
              </p:ext>
            </p:extLst>
          </p:nvPr>
        </p:nvGraphicFramePr>
        <p:xfrm>
          <a:off x="1733693" y="973809"/>
          <a:ext cx="7532464" cy="2753237"/>
        </p:xfrm>
        <a:graphic>
          <a:graphicData uri="http://schemas.openxmlformats.org/drawingml/2006/table">
            <a:tbl>
              <a:tblPr firstRow="1" firstCol="1" bandRow="1"/>
              <a:tblGrid>
                <a:gridCol w="1064044">
                  <a:extLst>
                    <a:ext uri="{9D8B030D-6E8A-4147-A177-3AD203B41FA5}">
                      <a16:colId xmlns:a16="http://schemas.microsoft.com/office/drawing/2014/main" val="2986954681"/>
                    </a:ext>
                  </a:extLst>
                </a:gridCol>
                <a:gridCol w="602314">
                  <a:extLst>
                    <a:ext uri="{9D8B030D-6E8A-4147-A177-3AD203B41FA5}">
                      <a16:colId xmlns:a16="http://schemas.microsoft.com/office/drawing/2014/main" val="2482539355"/>
                    </a:ext>
                  </a:extLst>
                </a:gridCol>
                <a:gridCol w="602314">
                  <a:extLst>
                    <a:ext uri="{9D8B030D-6E8A-4147-A177-3AD203B41FA5}">
                      <a16:colId xmlns:a16="http://schemas.microsoft.com/office/drawing/2014/main" val="1131285088"/>
                    </a:ext>
                  </a:extLst>
                </a:gridCol>
                <a:gridCol w="686950">
                  <a:extLst>
                    <a:ext uri="{9D8B030D-6E8A-4147-A177-3AD203B41FA5}">
                      <a16:colId xmlns:a16="http://schemas.microsoft.com/office/drawing/2014/main" val="2246378118"/>
                    </a:ext>
                  </a:extLst>
                </a:gridCol>
                <a:gridCol w="686950">
                  <a:extLst>
                    <a:ext uri="{9D8B030D-6E8A-4147-A177-3AD203B41FA5}">
                      <a16:colId xmlns:a16="http://schemas.microsoft.com/office/drawing/2014/main" val="3577966141"/>
                    </a:ext>
                  </a:extLst>
                </a:gridCol>
                <a:gridCol w="1311364">
                  <a:extLst>
                    <a:ext uri="{9D8B030D-6E8A-4147-A177-3AD203B41FA5}">
                      <a16:colId xmlns:a16="http://schemas.microsoft.com/office/drawing/2014/main" val="2688208810"/>
                    </a:ext>
                  </a:extLst>
                </a:gridCol>
                <a:gridCol w="602314">
                  <a:extLst>
                    <a:ext uri="{9D8B030D-6E8A-4147-A177-3AD203B41FA5}">
                      <a16:colId xmlns:a16="http://schemas.microsoft.com/office/drawing/2014/main" val="4029740057"/>
                    </a:ext>
                  </a:extLst>
                </a:gridCol>
                <a:gridCol w="602314">
                  <a:extLst>
                    <a:ext uri="{9D8B030D-6E8A-4147-A177-3AD203B41FA5}">
                      <a16:colId xmlns:a16="http://schemas.microsoft.com/office/drawing/2014/main" val="480436180"/>
                    </a:ext>
                  </a:extLst>
                </a:gridCol>
                <a:gridCol w="686950">
                  <a:extLst>
                    <a:ext uri="{9D8B030D-6E8A-4147-A177-3AD203B41FA5}">
                      <a16:colId xmlns:a16="http://schemas.microsoft.com/office/drawing/2014/main" val="3974583596"/>
                    </a:ext>
                  </a:extLst>
                </a:gridCol>
                <a:gridCol w="686950">
                  <a:extLst>
                    <a:ext uri="{9D8B030D-6E8A-4147-A177-3AD203B41FA5}">
                      <a16:colId xmlns:a16="http://schemas.microsoft.com/office/drawing/2014/main" val="2858746502"/>
                    </a:ext>
                  </a:extLst>
                </a:gridCol>
              </a:tblGrid>
              <a:tr h="386708">
                <a:tc rowSpan="2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b="1" kern="100" dirty="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Product Nkabinde and Antiretroviral drugs</a:t>
                      </a:r>
                      <a:endParaRPr lang="en-ZA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4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b="1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                           FICI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b="1" i="1" kern="100" dirty="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Gnidia sericocephala</a:t>
                      </a:r>
                      <a:r>
                        <a:rPr lang="en-ZA" sz="1200" b="1" kern="100" dirty="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 and    Antiretroviral drugs</a:t>
                      </a:r>
                      <a:endParaRPr lang="en-ZA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4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b="1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                                FICI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16118615"/>
                  </a:ext>
                </a:extLst>
              </a:tr>
              <a:tr h="819697">
                <a:tc v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b="1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NL4.3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b="1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CM070P.1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b="1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YU2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b="1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CM019P.1.2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b="1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NL4.3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b="1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CM070P.1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b="1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YU2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b="1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CM019P.1.2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89896258"/>
                  </a:ext>
                </a:extLst>
              </a:tr>
              <a:tr h="38670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AZT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.3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.5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.9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3.1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AZT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3.0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.2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.8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.4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57341590"/>
                  </a:ext>
                </a:extLst>
              </a:tr>
              <a:tr h="38670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Maraviroc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.0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.7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3.2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.1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Maraviroc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.9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3.0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.6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.2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53935196"/>
                  </a:ext>
                </a:extLst>
              </a:tr>
              <a:tr h="38670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Raltegravir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.2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.9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3.1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.8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Raltegravir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.5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.9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3.5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6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63803496"/>
                  </a:ext>
                </a:extLst>
              </a:tr>
              <a:tr h="38670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Amprenavir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.7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.0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.6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.9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Amprenavir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.4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3.1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3.5</a:t>
                      </a:r>
                      <a:endParaRPr lang="en-ZA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200" kern="100" dirty="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8</a:t>
                      </a:r>
                      <a:endParaRPr lang="en-ZA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8405280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1383395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67</TotalTime>
  <Words>150</Words>
  <Application>Microsoft Office PowerPoint</Application>
  <PresentationFormat>Widescreen</PresentationFormat>
  <Paragraphs>59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hanyisile Mngomezulu (210514678)</dc:creator>
  <cp:lastModifiedBy>Khanyisile Mngomezulu (210514678)</cp:lastModifiedBy>
  <cp:revision>3</cp:revision>
  <dcterms:created xsi:type="dcterms:W3CDTF">2025-04-25T11:06:47Z</dcterms:created>
  <dcterms:modified xsi:type="dcterms:W3CDTF">2025-05-23T09:53:37Z</dcterms:modified>
</cp:coreProperties>
</file>